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771"/>
    <p:restoredTop sz="94658"/>
  </p:normalViewPr>
  <p:slideViewPr>
    <p:cSldViewPr snapToGrid="0">
      <p:cViewPr varScale="1">
        <p:scale>
          <a:sx n="120" d="100"/>
          <a:sy n="120" d="100"/>
        </p:scale>
        <p:origin x="7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069F1F-6B4A-A538-9931-142D04369E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73AF2E5-1820-EDB5-0D91-7AA5E2521B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62DFB4-8ACA-3981-6143-23A7A78A9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973311-A943-D3B4-4329-B4908FF98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ED4188-1520-64DC-C720-142A3927A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49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CC5741-5BDE-14D5-5E69-9CF45747FF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9131BA-7D83-5F01-4C3C-BB9F1545FC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65C3A2-F547-8F03-20AF-752631F05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E2B05D-A6C4-ED4C-DD99-F72FCF372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5266B-189F-1404-9950-3B88DDA8A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748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0746F8-5C43-8BAE-0432-70FC0D820A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E4CD54-1499-CEB4-9B2C-E3D94D69B9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2A3E22-4EDC-FCC2-3361-DE6C91360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88EDCC-33CA-3577-12F9-AA05073EE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0CBC43-D547-14CC-5BD6-BE0A26D5E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409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998BFD-D159-A64D-BF68-F80A2FE198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0D0A06-7E1E-38C7-5218-FE184F84CB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8910D4-9990-14F9-6BF9-083F06A52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E0A216-491F-9756-B324-9E69D68F6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F7196E-E18F-5DA2-ED7A-ED5460E7E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182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83210-8257-3236-5AA9-E4A38AAFC6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EE16A8-6AB3-13EA-02DC-256E2BAC4C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645ACE-16F2-08D6-0694-26D1C379E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B30563-FC07-ACE6-C589-E761C0DDE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2B63AA-6816-F2D6-2360-FF6E57583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014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DCA6E4-C1D2-3D6D-314B-7FB8C7F383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2ABA23-B526-FCC0-FD6D-378077553A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704064-09FA-A968-9844-3F1863EF29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DCCD25-0176-7175-B8E7-0C55E82045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2F8756-D9C7-F53E-5936-795D6DE7C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D01D19-9E75-502F-5350-7331DFFFA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733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00B00A-F40D-20EC-97C6-8DC6D362EA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F40F2E-1072-349F-A03D-D176CF4B45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852786-F6FF-2126-9F17-A4444AE7C4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462C7E-8D74-5C9A-C592-1D55A96960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3A8D01-9558-F64E-2BED-E709E4747A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2DE440-9F79-EA87-D55B-DDCE523AE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9640A2-56AA-BC31-82E4-7A343A188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5A9CE9-8EB5-A91F-30C8-E798AC85D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521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F576E-E807-9B29-EE95-6D03767504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A3DAEA-28F9-605B-56F4-63839DB17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22E048-942E-9354-B672-691E2D05C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919DBE5-B0B2-9642-8045-25F541AAF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698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E732A2-851F-8DF9-7D68-520AD3B72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811E4D8-DCA5-5358-639F-779014BF77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C7EFC1F-75E7-B56C-88D2-78158734A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652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4A6E18-5AFD-D9A3-F911-65C6A4826A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EFBD6B-4458-E14E-8CB5-94380CB410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893511-27E5-EDE6-2DD9-02AE206E47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567686-01C9-70DA-8031-31F912BAD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3B3B23-F384-812A-A9A1-19C864646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FC91F0-7018-9D49-269C-C3FF904C1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655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98A19F-1AC9-CEEE-8EE8-41468C0283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E65590A-079E-59C5-D7EF-0F966A7193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153545-3BC3-C2EC-4B30-6188706F35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F476E5-B3B7-CCB7-8786-8276558E1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240392-F8FC-857F-4466-AC11965FB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FC9DDD-CE44-B981-46FF-03178DE7B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20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6335417-642B-8622-310C-332C4ACF1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80CF0B-AD49-4418-11CB-32915EA563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7FDD8F-9ECB-807D-8446-14701868B4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5D14FF-EC5F-C243-972B-AFAFB02ADC44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C3E5C8-9DF9-41B9-8BDE-025436E1BA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9101B0-9B61-B75D-E565-A1E334FD94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B3D2E6B-8AE1-5143-A9C4-AB6AE146F8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907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91D3300-132C-EBB2-1662-FBA138EC450D}"/>
              </a:ext>
            </a:extLst>
          </p:cNvPr>
          <p:cNvSpPr txBox="1"/>
          <p:nvPr/>
        </p:nvSpPr>
        <p:spPr>
          <a:xfrm rot="16200000">
            <a:off x="295194" y="2681590"/>
            <a:ext cx="3159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nset of &gt;Grade 2 GI Toxicity</a:t>
            </a:r>
          </a:p>
        </p:txBody>
      </p:sp>
      <p:pic>
        <p:nvPicPr>
          <p:cNvPr id="4" name="Picture 3" descr="A graph showing a graph of a staircase&#10;&#10;AI-generated content may be incorrect.">
            <a:extLst>
              <a:ext uri="{FF2B5EF4-FFF2-40B4-BE49-F238E27FC236}">
                <a16:creationId xmlns:a16="http://schemas.microsoft.com/office/drawing/2014/main" id="{04CE4B81-83C9-387E-796F-BF1F3EBB8BD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250" b="12517"/>
          <a:stretch/>
        </p:blipFill>
        <p:spPr>
          <a:xfrm>
            <a:off x="2079321" y="302479"/>
            <a:ext cx="8042494" cy="5252814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8F91E0F1-F8BA-75A7-521B-09DB74AC7C47}"/>
              </a:ext>
            </a:extLst>
          </p:cNvPr>
          <p:cNvGrpSpPr/>
          <p:nvPr/>
        </p:nvGrpSpPr>
        <p:grpSpPr>
          <a:xfrm>
            <a:off x="2970756" y="3507287"/>
            <a:ext cx="3616190" cy="818961"/>
            <a:chOff x="2970756" y="3313134"/>
            <a:chExt cx="3616190" cy="818961"/>
          </a:xfrm>
        </p:grpSpPr>
        <p:pic>
          <p:nvPicPr>
            <p:cNvPr id="5" name="Picture 4" descr="A graph showing a graph of a staircase&#10;&#10;AI-generated content may be incorrect.">
              <a:extLst>
                <a:ext uri="{FF2B5EF4-FFF2-40B4-BE49-F238E27FC236}">
                  <a16:creationId xmlns:a16="http://schemas.microsoft.com/office/drawing/2014/main" id="{473088FC-B8F2-7219-2B79-3FC46A82823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9129" t="94680" r="61551" b="1877"/>
            <a:stretch/>
          </p:blipFill>
          <p:spPr>
            <a:xfrm>
              <a:off x="2970756" y="3394552"/>
              <a:ext cx="782878" cy="206680"/>
            </a:xfrm>
            <a:prstGeom prst="rect">
              <a:avLst/>
            </a:prstGeom>
          </p:spPr>
        </p:pic>
        <p:pic>
          <p:nvPicPr>
            <p:cNvPr id="7" name="Picture 6" descr="A graph showing a graph of a staircase&#10;&#10;AI-generated content may be incorrect.">
              <a:extLst>
                <a:ext uri="{FF2B5EF4-FFF2-40B4-BE49-F238E27FC236}">
                  <a16:creationId xmlns:a16="http://schemas.microsoft.com/office/drawing/2014/main" id="{7EC2A842-0237-CB50-50E1-7FCE04024A7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7050" t="94924" r="13629" b="2156"/>
            <a:stretch/>
          </p:blipFill>
          <p:spPr>
            <a:xfrm>
              <a:off x="2970756" y="3905914"/>
              <a:ext cx="782878" cy="175365"/>
            </a:xfrm>
            <a:prstGeom prst="rect">
              <a:avLst/>
            </a:prstGeom>
          </p:spPr>
        </p:pic>
        <p:pic>
          <p:nvPicPr>
            <p:cNvPr id="8" name="Picture 7" descr="A graph showing a graph of a staircase&#10;&#10;AI-generated content may be incorrect.">
              <a:extLst>
                <a:ext uri="{FF2B5EF4-FFF2-40B4-BE49-F238E27FC236}">
                  <a16:creationId xmlns:a16="http://schemas.microsoft.com/office/drawing/2014/main" id="{351B1CF4-1C07-3534-6BBC-A98E56D8AA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55699" t="94993" r="35428" b="2087"/>
            <a:stretch/>
          </p:blipFill>
          <p:spPr>
            <a:xfrm>
              <a:off x="2989546" y="3667918"/>
              <a:ext cx="745298" cy="175365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3787B55-EF5E-B326-53B4-27FA7A2199E1}"/>
                </a:ext>
              </a:extLst>
            </p:cNvPr>
            <p:cNvSpPr txBox="1"/>
            <p:nvPr/>
          </p:nvSpPr>
          <p:spPr>
            <a:xfrm>
              <a:off x="3845490" y="3359392"/>
              <a:ext cx="26068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&lt;20% soluble E-selectin Reductio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34CBA8E-37DE-79C3-E297-989E0B0D66DF}"/>
                </a:ext>
              </a:extLst>
            </p:cNvPr>
            <p:cNvSpPr txBox="1"/>
            <p:nvPr/>
          </p:nvSpPr>
          <p:spPr>
            <a:xfrm>
              <a:off x="3845490" y="3611338"/>
              <a:ext cx="27414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0-40% soluble E-selectin Reductio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157D533-D327-E50C-63EF-516445CE2495}"/>
                </a:ext>
              </a:extLst>
            </p:cNvPr>
            <p:cNvSpPr txBox="1"/>
            <p:nvPr/>
          </p:nvSpPr>
          <p:spPr>
            <a:xfrm>
              <a:off x="3885340" y="3855096"/>
              <a:ext cx="26068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&gt;40% soluble E-selectin Reduction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307E5147-D1CA-DC94-EC51-71E89D47538B}"/>
                </a:ext>
              </a:extLst>
            </p:cNvPr>
            <p:cNvSpPr/>
            <p:nvPr/>
          </p:nvSpPr>
          <p:spPr>
            <a:xfrm>
              <a:off x="2970756" y="3313134"/>
              <a:ext cx="3616190" cy="81896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4AE5F947-D284-8995-49EC-BF816B2ECE2E}"/>
              </a:ext>
            </a:extLst>
          </p:cNvPr>
          <p:cNvSpPr txBox="1"/>
          <p:nvPr/>
        </p:nvSpPr>
        <p:spPr>
          <a:xfrm>
            <a:off x="5566794" y="5492506"/>
            <a:ext cx="1881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ays post-AHCT</a:t>
            </a:r>
          </a:p>
        </p:txBody>
      </p:sp>
    </p:spTree>
    <p:extLst>
      <p:ext uri="{BB962C8B-B14F-4D97-AF65-F5344CB8AC3E}">
        <p14:creationId xmlns:p14="http://schemas.microsoft.com/office/powerpoint/2010/main" val="3181522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63</TotalTime>
  <Words>26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rees, Zachary</dc:creator>
  <cp:lastModifiedBy>Crees, Zachary</cp:lastModifiedBy>
  <cp:revision>4</cp:revision>
  <dcterms:created xsi:type="dcterms:W3CDTF">2025-06-08T20:34:56Z</dcterms:created>
  <dcterms:modified xsi:type="dcterms:W3CDTF">2025-10-24T05:16:11Z</dcterms:modified>
</cp:coreProperties>
</file>